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83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 showGuides="1">
      <p:cViewPr varScale="1">
        <p:scale>
          <a:sx n="79" d="100"/>
          <a:sy n="79" d="100"/>
        </p:scale>
        <p:origin x="72" y="99"/>
      </p:cViewPr>
      <p:guideLst>
        <p:guide orient="horz" pos="2183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D1C6977-D216-4291-B526-24CC8A910D7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F4E819DA-E588-4B0A-A85F-6AAF1536CA5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8F0E27F-6504-48A1-B026-48B7A284FD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9C76E8-4DEE-46D5-87C9-AC4597678858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E127B5D-27EA-4522-8840-85595DA92F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3126476-36A6-4A57-A005-4D34447444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32CFDC-4388-448E-98EC-A6C003BD0B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05654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515FD5E-A4EB-49A3-819D-4387AE1238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97DBD9C-D5B3-4126-8F4A-86ECADD6480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935295E-D8F3-4414-9340-A82901FC4C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9C76E8-4DEE-46D5-87C9-AC4597678858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917BD3A-0ED1-436C-B750-C7965A39EF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2A1A116-B04E-48CA-A601-D7EE6EAE97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32CFDC-4388-448E-98EC-A6C003BD0B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142855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7D492959-BF20-4DE3-B543-24096EDBB06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DC704F4-9470-4957-8E6C-E50A5307CC7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42C2DB8-95A1-4B1F-8E9B-190B5608CA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9C76E8-4DEE-46D5-87C9-AC4597678858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EC57BD1-F42F-498A-AD38-61822CB9F3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4A68442-C7EF-4E56-A14F-F31117929E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32CFDC-4388-448E-98EC-A6C003BD0B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79461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42A0D55-D327-4FE8-87A1-3742335CEE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0C2A1E1-A44A-4176-A885-F367F46CF84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C4DF497-C7BB-4CA7-8FE4-62EA76DCF4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9C76E8-4DEE-46D5-87C9-AC4597678858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441E769-2908-4094-A7FB-7E1B35E6EC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BA835E1-2252-4023-BEEC-F9A6ED0E6B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32CFDC-4388-448E-98EC-A6C003BD0B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689531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216704A-9351-404B-970C-D6C1C25A57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16B2DAE-C485-47A5-88AE-0AA23F4145D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AB0926B-E135-49D8-B821-902AE35DC2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9C76E8-4DEE-46D5-87C9-AC4597678858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54C258E-ED83-4FF7-98F3-D4F7B9E17B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3D70969-3A83-4588-84F3-2D61A0BB66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32CFDC-4388-448E-98EC-A6C003BD0B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120924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37739C9-E45F-48DA-B71D-407784BB8B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B6741FC-E564-48E5-BF0D-9A221A945CF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CD6CBE5-A611-4EDA-957B-933CB3AEAD8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6181157-58C2-4132-B584-F487E2CED4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9C76E8-4DEE-46D5-87C9-AC4597678858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5691C27-FC5A-4C65-8542-3B5F842A72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E7E3B68-50E6-4104-BA53-28BE11155A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32CFDC-4388-448E-98EC-A6C003BD0B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374777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741CCF1-8108-407C-97A7-ED484BB192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D7C5596-C278-4111-B13E-1CD495FFA94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42E6297-5CD9-4358-8586-478EE1AD3C1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86A2DF83-BDA1-471B-BDF1-90C7728AAE5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89666EC0-76DA-46F8-958C-5C712BBAFAC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91D2B55E-C999-423B-83B6-365A6A618F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9C76E8-4DEE-46D5-87C9-AC4597678858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05CA4877-FC50-49A1-B21C-296E342C11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CED5BF4C-F0B8-41DF-9BF2-809372C63E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32CFDC-4388-448E-98EC-A6C003BD0B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587863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E502D65-2753-434D-A446-9CA5CB282B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0961ED1F-3E4B-4CBB-A9A4-5B8D85CA48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9C76E8-4DEE-46D5-87C9-AC4597678858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AAA2ABDA-853F-40C1-B1B1-DBA6C1A585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CDDBB48D-8D78-4869-B5CE-8B4C59CA12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32CFDC-4388-448E-98EC-A6C003BD0B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828928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5E78968C-5649-4C36-9FA8-C0944E32E6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9C76E8-4DEE-46D5-87C9-AC4597678858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9A9D6C08-6F79-4690-B350-D9D1B9342A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261D66B4-3F77-4524-A474-D441B8DB11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32CFDC-4388-448E-98EC-A6C003BD0B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78605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1AD3EB4-DCAC-4AF4-8C49-6CD2AC84C6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243BC7E-8E40-40F0-AF2F-CEB250BACC9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9CD86E2-8215-49E0-A1D8-81BF906A8F0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12DD22C-16A7-4A28-BDEC-B22C07C7D6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9C76E8-4DEE-46D5-87C9-AC4597678858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72F10A4-AA8A-45F6-9988-28BAC7B8FA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2C14F39-911C-4B30-A568-EED8882CD5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32CFDC-4388-448E-98EC-A6C003BD0B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422596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A77B106-0EFB-4477-82B9-0E01F5781D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DA0DDF9F-12A2-41CE-A6B6-5AE5DD0FF51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858490D-E404-4FFD-B458-0999526CF40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998FEFA-FA97-4528-9732-8DC25362F9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9C76E8-4DEE-46D5-87C9-AC4597678858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B209EC4-F91E-4ECA-A09B-39F83AAD95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C580BE4-0F01-46B8-8B20-AC34DA5E3D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32CFDC-4388-448E-98EC-A6C003BD0B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645767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4FB01381-7028-440A-8253-21A9D80107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E26A5E0-7FDA-4D3A-AC59-E949FC1E291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D854F65-5E26-484B-9B10-F6C29E034B0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9C76E8-4DEE-46D5-87C9-AC4597678858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22AA2AE-8C4E-48A7-98A6-C156625E8DB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058CEAB-938D-4236-8C23-3577CCED638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32CFDC-4388-448E-98EC-A6C003BD0B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78347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03125351-85BB-42FE-AEDA-64BE422B64B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705" t="27162" r="31583" b="26387"/>
          <a:stretch/>
        </p:blipFill>
        <p:spPr>
          <a:xfrm>
            <a:off x="1715858" y="2344294"/>
            <a:ext cx="3697356" cy="2769704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6AAFEC1F-0E23-4AC2-863D-F557ABDE67B1}"/>
              </a:ext>
            </a:extLst>
          </p:cNvPr>
          <p:cNvSpPr txBox="1"/>
          <p:nvPr/>
        </p:nvSpPr>
        <p:spPr>
          <a:xfrm>
            <a:off x="4426225" y="636104"/>
            <a:ext cx="336605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400" b="1" dirty="0"/>
              <a:t>CD36</a:t>
            </a:r>
            <a:endParaRPr lang="zh-CN" altLang="en-US" sz="2400" b="1" dirty="0"/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6154AD68-6632-4EE0-8186-6CFE23542D8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035" t="19162" r="20701" b="36165"/>
          <a:stretch/>
        </p:blipFill>
        <p:spPr>
          <a:xfrm>
            <a:off x="5864386" y="2344294"/>
            <a:ext cx="4611756" cy="2663687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DE87D820-A225-414C-BCAE-FA16F2656DDC}"/>
              </a:ext>
            </a:extLst>
          </p:cNvPr>
          <p:cNvSpPr txBox="1"/>
          <p:nvPr/>
        </p:nvSpPr>
        <p:spPr>
          <a:xfrm>
            <a:off x="2312804" y="2008885"/>
            <a:ext cx="35515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HI   HF HFL HFH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7A7479AA-47CB-40BA-A742-FCF522537C7B}"/>
              </a:ext>
            </a:extLst>
          </p:cNvPr>
          <p:cNvSpPr txBox="1"/>
          <p:nvPr/>
        </p:nvSpPr>
        <p:spPr>
          <a:xfrm>
            <a:off x="6361346" y="2002261"/>
            <a:ext cx="35515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HI   HF HFL HFH DFO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9D8E184C-D403-4C97-83CC-96E203D4A492}"/>
              </a:ext>
            </a:extLst>
          </p:cNvPr>
          <p:cNvSpPr txBox="1"/>
          <p:nvPr/>
        </p:nvSpPr>
        <p:spPr>
          <a:xfrm>
            <a:off x="2544418" y="5343389"/>
            <a:ext cx="2120347" cy="3417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w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4B539077-68AC-4576-8412-84C3D6858A5F}"/>
              </a:ext>
            </a:extLst>
          </p:cNvPr>
          <p:cNvSpPr txBox="1"/>
          <p:nvPr/>
        </p:nvSpPr>
        <p:spPr>
          <a:xfrm>
            <a:off x="6844756" y="5350017"/>
            <a:ext cx="2120347" cy="3417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w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94193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6AAFEC1F-0E23-4AC2-863D-F557ABDE67B1}"/>
              </a:ext>
            </a:extLst>
          </p:cNvPr>
          <p:cNvSpPr txBox="1"/>
          <p:nvPr/>
        </p:nvSpPr>
        <p:spPr>
          <a:xfrm>
            <a:off x="4426225" y="636104"/>
            <a:ext cx="336605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400" b="1" dirty="0"/>
              <a:t>FAS</a:t>
            </a:r>
            <a:endParaRPr lang="zh-CN" altLang="en-US" sz="2400" b="1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DE87D820-A225-414C-BCAE-FA16F2656DDC}"/>
              </a:ext>
            </a:extLst>
          </p:cNvPr>
          <p:cNvSpPr txBox="1"/>
          <p:nvPr/>
        </p:nvSpPr>
        <p:spPr>
          <a:xfrm>
            <a:off x="2312804" y="2008885"/>
            <a:ext cx="35515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HI   HF HFL HFH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7A7479AA-47CB-40BA-A742-FCF522537C7B}"/>
              </a:ext>
            </a:extLst>
          </p:cNvPr>
          <p:cNvSpPr txBox="1"/>
          <p:nvPr/>
        </p:nvSpPr>
        <p:spPr>
          <a:xfrm>
            <a:off x="6361346" y="2002261"/>
            <a:ext cx="35515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HI   HF HFL HFH DFO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B3557852-A814-4B89-8B01-79EB0FEE795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384" t="6717" r="26394" b="57501"/>
          <a:stretch/>
        </p:blipFill>
        <p:spPr>
          <a:xfrm>
            <a:off x="1901992" y="2281503"/>
            <a:ext cx="3896140" cy="2133600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3AB98AA4-8713-44B9-99FC-806A5F9322D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542" t="8050" r="37276" b="69245"/>
          <a:stretch/>
        </p:blipFill>
        <p:spPr>
          <a:xfrm>
            <a:off x="6298546" y="2413941"/>
            <a:ext cx="3180522" cy="1353851"/>
          </a:xfrm>
          <a:prstGeom prst="rect">
            <a:avLst/>
          </a:prstGeom>
        </p:spPr>
      </p:pic>
      <p:sp>
        <p:nvSpPr>
          <p:cNvPr id="21" name="文本框 20">
            <a:extLst>
              <a:ext uri="{FF2B5EF4-FFF2-40B4-BE49-F238E27FC236}">
                <a16:creationId xmlns:a16="http://schemas.microsoft.com/office/drawing/2014/main" id="{E8F0B5D9-32CF-4A0F-AF55-FFC375D3EAF1}"/>
              </a:ext>
            </a:extLst>
          </p:cNvPr>
          <p:cNvSpPr txBox="1"/>
          <p:nvPr/>
        </p:nvSpPr>
        <p:spPr>
          <a:xfrm>
            <a:off x="2544418" y="4402484"/>
            <a:ext cx="2120347" cy="3417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w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CC1CB2D6-E46C-4BF9-A49F-FB81EF922282}"/>
              </a:ext>
            </a:extLst>
          </p:cNvPr>
          <p:cNvSpPr txBox="1"/>
          <p:nvPr/>
        </p:nvSpPr>
        <p:spPr>
          <a:xfrm>
            <a:off x="6844756" y="4409112"/>
            <a:ext cx="2120347" cy="3417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w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8421679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6AAFEC1F-0E23-4AC2-863D-F557ABDE67B1}"/>
              </a:ext>
            </a:extLst>
          </p:cNvPr>
          <p:cNvSpPr txBox="1"/>
          <p:nvPr/>
        </p:nvSpPr>
        <p:spPr>
          <a:xfrm>
            <a:off x="4426225" y="636104"/>
            <a:ext cx="336605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400" b="1" dirty="0"/>
              <a:t>CPT1</a:t>
            </a:r>
            <a:endParaRPr lang="zh-CN" altLang="en-US" sz="2400" b="1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DE87D820-A225-414C-BCAE-FA16F2656DDC}"/>
              </a:ext>
            </a:extLst>
          </p:cNvPr>
          <p:cNvSpPr txBox="1"/>
          <p:nvPr/>
        </p:nvSpPr>
        <p:spPr>
          <a:xfrm>
            <a:off x="2312804" y="2008885"/>
            <a:ext cx="35515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HI   HF HFL HFH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7A7479AA-47CB-40BA-A742-FCF522537C7B}"/>
              </a:ext>
            </a:extLst>
          </p:cNvPr>
          <p:cNvSpPr txBox="1"/>
          <p:nvPr/>
        </p:nvSpPr>
        <p:spPr>
          <a:xfrm>
            <a:off x="6361346" y="2002261"/>
            <a:ext cx="35515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HI   HF HFL HFH DFO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0B95AA2C-9B32-4CBC-86A2-8B1FD9F78CDF}"/>
              </a:ext>
            </a:extLst>
          </p:cNvPr>
          <p:cNvSpPr txBox="1"/>
          <p:nvPr/>
        </p:nvSpPr>
        <p:spPr>
          <a:xfrm>
            <a:off x="2544418" y="5396398"/>
            <a:ext cx="2120347" cy="3417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w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6F5D6C57-CC2B-4CFA-B0A8-53477E556D00}"/>
              </a:ext>
            </a:extLst>
          </p:cNvPr>
          <p:cNvSpPr txBox="1"/>
          <p:nvPr/>
        </p:nvSpPr>
        <p:spPr>
          <a:xfrm>
            <a:off x="6844756" y="5403026"/>
            <a:ext cx="2120347" cy="3417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w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50523966-6CAA-4672-8E68-38447CA5B1E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180" t="3160" r="26225" b="55500"/>
          <a:stretch/>
        </p:blipFill>
        <p:spPr>
          <a:xfrm>
            <a:off x="6208944" y="2369741"/>
            <a:ext cx="4558748" cy="2464906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E720219C-4E1A-4097-8B40-6DB0E7EAB2C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492" r="30914" b="58661"/>
          <a:stretch/>
        </p:blipFill>
        <p:spPr>
          <a:xfrm>
            <a:off x="1477917" y="2347439"/>
            <a:ext cx="4558748" cy="24649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9530241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6AAFEC1F-0E23-4AC2-863D-F557ABDE67B1}"/>
              </a:ext>
            </a:extLst>
          </p:cNvPr>
          <p:cNvSpPr txBox="1"/>
          <p:nvPr/>
        </p:nvSpPr>
        <p:spPr>
          <a:xfrm>
            <a:off x="4426225" y="636104"/>
            <a:ext cx="336605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400" b="1" dirty="0"/>
              <a:t>p-ACC</a:t>
            </a:r>
            <a:endParaRPr lang="zh-CN" altLang="en-US" sz="2400" b="1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DE87D820-A225-414C-BCAE-FA16F2656DDC}"/>
              </a:ext>
            </a:extLst>
          </p:cNvPr>
          <p:cNvSpPr txBox="1"/>
          <p:nvPr/>
        </p:nvSpPr>
        <p:spPr>
          <a:xfrm>
            <a:off x="2312804" y="2008885"/>
            <a:ext cx="35515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HI   HF HFL HFH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7A7479AA-47CB-40BA-A742-FCF522537C7B}"/>
              </a:ext>
            </a:extLst>
          </p:cNvPr>
          <p:cNvSpPr txBox="1"/>
          <p:nvPr/>
        </p:nvSpPr>
        <p:spPr>
          <a:xfrm>
            <a:off x="6361346" y="2002261"/>
            <a:ext cx="35515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HI   HF HFL HFH DFO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0B95AA2C-9B32-4CBC-86A2-8B1FD9F78CDF}"/>
              </a:ext>
            </a:extLst>
          </p:cNvPr>
          <p:cNvSpPr txBox="1"/>
          <p:nvPr/>
        </p:nvSpPr>
        <p:spPr>
          <a:xfrm>
            <a:off x="2544418" y="5396398"/>
            <a:ext cx="2120347" cy="3417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w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6F5D6C57-CC2B-4CFA-B0A8-53477E556D00}"/>
              </a:ext>
            </a:extLst>
          </p:cNvPr>
          <p:cNvSpPr txBox="1"/>
          <p:nvPr/>
        </p:nvSpPr>
        <p:spPr>
          <a:xfrm>
            <a:off x="6844756" y="5403026"/>
            <a:ext cx="2120347" cy="3417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w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内容占位符 4">
            <a:extLst>
              <a:ext uri="{FF2B5EF4-FFF2-40B4-BE49-F238E27FC236}">
                <a16:creationId xmlns:a16="http://schemas.microsoft.com/office/drawing/2014/main" id="{E8497B31-77BD-06A8-A408-645922881BB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495" t="-1261" r="-1391" b="46490"/>
          <a:stretch/>
        </p:blipFill>
        <p:spPr>
          <a:xfrm>
            <a:off x="520658" y="2527443"/>
            <a:ext cx="5308187" cy="2383256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ED85F508-7FF1-7EC4-8465-ADEDBC30BC2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11406" b="45276"/>
          <a:stretch/>
        </p:blipFill>
        <p:spPr>
          <a:xfrm>
            <a:off x="5457609" y="2670398"/>
            <a:ext cx="5120337" cy="23787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6078284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6AAFEC1F-0E23-4AC2-863D-F557ABDE67B1}"/>
              </a:ext>
            </a:extLst>
          </p:cNvPr>
          <p:cNvSpPr txBox="1"/>
          <p:nvPr/>
        </p:nvSpPr>
        <p:spPr>
          <a:xfrm>
            <a:off x="4426225" y="636104"/>
            <a:ext cx="336605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400" b="1" dirty="0"/>
              <a:t>ACC</a:t>
            </a:r>
            <a:endParaRPr lang="zh-CN" altLang="en-US" sz="2400" b="1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DE87D820-A225-414C-BCAE-FA16F2656DDC}"/>
              </a:ext>
            </a:extLst>
          </p:cNvPr>
          <p:cNvSpPr txBox="1"/>
          <p:nvPr/>
        </p:nvSpPr>
        <p:spPr>
          <a:xfrm>
            <a:off x="2312804" y="2008885"/>
            <a:ext cx="35515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HI   HF HFL HFH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7A7479AA-47CB-40BA-A742-FCF522537C7B}"/>
              </a:ext>
            </a:extLst>
          </p:cNvPr>
          <p:cNvSpPr txBox="1"/>
          <p:nvPr/>
        </p:nvSpPr>
        <p:spPr>
          <a:xfrm>
            <a:off x="6361346" y="2002261"/>
            <a:ext cx="35515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HI   HF HFL HFH DFO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0B95AA2C-9B32-4CBC-86A2-8B1FD9F78CDF}"/>
              </a:ext>
            </a:extLst>
          </p:cNvPr>
          <p:cNvSpPr txBox="1"/>
          <p:nvPr/>
        </p:nvSpPr>
        <p:spPr>
          <a:xfrm>
            <a:off x="2544418" y="4791487"/>
            <a:ext cx="2120347" cy="3417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w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6F5D6C57-CC2B-4CFA-B0A8-53477E556D00}"/>
              </a:ext>
            </a:extLst>
          </p:cNvPr>
          <p:cNvSpPr txBox="1"/>
          <p:nvPr/>
        </p:nvSpPr>
        <p:spPr>
          <a:xfrm>
            <a:off x="6844756" y="4798115"/>
            <a:ext cx="2120347" cy="3417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w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1" name="图片 20">
            <a:extLst>
              <a:ext uri="{FF2B5EF4-FFF2-40B4-BE49-F238E27FC236}">
                <a16:creationId xmlns:a16="http://schemas.microsoft.com/office/drawing/2014/main" id="{23FFDC0A-403F-4949-A330-8E2018BA09A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16" t="1219" r="30331" b="69939"/>
          <a:stretch/>
        </p:blipFill>
        <p:spPr>
          <a:xfrm>
            <a:off x="1833490" y="2398673"/>
            <a:ext cx="3882683" cy="1719763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DC8C603D-2DEE-4BB4-B50D-7B28CD9E6D9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684" r="32464" b="60086"/>
          <a:stretch/>
        </p:blipFill>
        <p:spPr>
          <a:xfrm>
            <a:off x="6096000" y="2340815"/>
            <a:ext cx="4262510" cy="23799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9337523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6AAFEC1F-0E23-4AC2-863D-F557ABDE67B1}"/>
              </a:ext>
            </a:extLst>
          </p:cNvPr>
          <p:cNvSpPr txBox="1"/>
          <p:nvPr/>
        </p:nvSpPr>
        <p:spPr>
          <a:xfrm>
            <a:off x="4426225" y="636104"/>
            <a:ext cx="336605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altLang="zh-CN" sz="2400" b="1" dirty="0"/>
              <a:t>β</a:t>
            </a:r>
            <a:r>
              <a:rPr lang="en-US" altLang="zh-CN" sz="2400" b="1" dirty="0"/>
              <a:t>-actin</a:t>
            </a:r>
            <a:endParaRPr lang="zh-CN" altLang="en-US" sz="2400" b="1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DE87D820-A225-414C-BCAE-FA16F2656DDC}"/>
              </a:ext>
            </a:extLst>
          </p:cNvPr>
          <p:cNvSpPr txBox="1"/>
          <p:nvPr/>
        </p:nvSpPr>
        <p:spPr>
          <a:xfrm>
            <a:off x="2142828" y="2002261"/>
            <a:ext cx="35515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HI   HF HFL HFH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7A7479AA-47CB-40BA-A742-FCF522537C7B}"/>
              </a:ext>
            </a:extLst>
          </p:cNvPr>
          <p:cNvSpPr txBox="1"/>
          <p:nvPr/>
        </p:nvSpPr>
        <p:spPr>
          <a:xfrm>
            <a:off x="6361346" y="2002261"/>
            <a:ext cx="35515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HI   HF HFL HFH DFO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0B95AA2C-9B32-4CBC-86A2-8B1FD9F78CDF}"/>
              </a:ext>
            </a:extLst>
          </p:cNvPr>
          <p:cNvSpPr txBox="1"/>
          <p:nvPr/>
        </p:nvSpPr>
        <p:spPr>
          <a:xfrm>
            <a:off x="2514138" y="5396398"/>
            <a:ext cx="2120347" cy="3417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w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6F5D6C57-CC2B-4CFA-B0A8-53477E556D00}"/>
              </a:ext>
            </a:extLst>
          </p:cNvPr>
          <p:cNvSpPr txBox="1"/>
          <p:nvPr/>
        </p:nvSpPr>
        <p:spPr>
          <a:xfrm>
            <a:off x="6844756" y="5403026"/>
            <a:ext cx="2120347" cy="3417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w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内容占位符 4">
            <a:extLst>
              <a:ext uri="{FF2B5EF4-FFF2-40B4-BE49-F238E27FC236}">
                <a16:creationId xmlns:a16="http://schemas.microsoft.com/office/drawing/2014/main" id="{38505CB2-951E-1D47-8AA1-B998256CB66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92" t="8516" r="53110" b="67081"/>
          <a:stretch/>
        </p:blipFill>
        <p:spPr>
          <a:xfrm>
            <a:off x="1812751" y="3014812"/>
            <a:ext cx="2419813" cy="1093061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92790B39-28FB-92E0-1680-6D50BDE958F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78212" y="2749193"/>
            <a:ext cx="3834716" cy="17679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48722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38</TotalTime>
  <Words>85</Words>
  <Application>Microsoft Office PowerPoint</Application>
  <PresentationFormat>宽屏</PresentationFormat>
  <Paragraphs>30</Paragraphs>
  <Slides>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1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419395953@qq.com</dc:creator>
  <cp:lastModifiedBy>代 雪征</cp:lastModifiedBy>
  <cp:revision>23</cp:revision>
  <dcterms:created xsi:type="dcterms:W3CDTF">2022-02-07T14:17:56Z</dcterms:created>
  <dcterms:modified xsi:type="dcterms:W3CDTF">2022-08-30T03:26:26Z</dcterms:modified>
</cp:coreProperties>
</file>